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262" r:id="rId2"/>
    <p:sldId id="257" r:id="rId3"/>
    <p:sldId id="276" r:id="rId4"/>
    <p:sldId id="277" r:id="rId5"/>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AD040BE-B8FA-E842-A715-AFDF6843583C}" v="4" dt="2025-11-15T07:13:13.80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37"/>
    <p:restoredTop sz="68776"/>
  </p:normalViewPr>
  <p:slideViewPr>
    <p:cSldViewPr snapToGrid="0">
      <p:cViewPr>
        <p:scale>
          <a:sx n="138" d="100"/>
          <a:sy n="138" d="100"/>
        </p:scale>
        <p:origin x="912" y="-40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عبدالرحمن عبدالله علي الاحمري" userId="68cdb2cc-7ab6-4d37-be63-1b932625588b" providerId="ADAL" clId="{78C43DE9-33FA-8C42-A629-6A64A7621F96}"/>
    <pc:docChg chg="delSld">
      <pc:chgData name="عبدالرحمن عبدالله علي الاحمري" userId="68cdb2cc-7ab6-4d37-be63-1b932625588b" providerId="ADAL" clId="{78C43DE9-33FA-8C42-A629-6A64A7621F96}" dt="2025-07-19T00:18:27.053" v="1" actId="2696"/>
      <pc:docMkLst>
        <pc:docMk/>
      </pc:docMkLst>
      <pc:sldChg chg="del">
        <pc:chgData name="عبدالرحمن عبدالله علي الاحمري" userId="68cdb2cc-7ab6-4d37-be63-1b932625588b" providerId="ADAL" clId="{78C43DE9-33FA-8C42-A629-6A64A7621F96}" dt="2025-07-19T00:18:27.053" v="1" actId="2696"/>
        <pc:sldMkLst>
          <pc:docMk/>
          <pc:sldMk cId="565855428" sldId="265"/>
        </pc:sldMkLst>
      </pc:sldChg>
      <pc:sldChg chg="del">
        <pc:chgData name="عبدالرحمن عبدالله علي الاحمري" userId="68cdb2cc-7ab6-4d37-be63-1b932625588b" providerId="ADAL" clId="{78C43DE9-33FA-8C42-A629-6A64A7621F96}" dt="2025-07-19T00:18:22.865" v="0" actId="2696"/>
        <pc:sldMkLst>
          <pc:docMk/>
          <pc:sldMk cId="3340310432" sldId="273"/>
        </pc:sldMkLst>
      </pc:sldChg>
    </pc:docChg>
  </pc:docChgLst>
  <pc:docChgLst>
    <pc:chgData name="عبدالرحمن عبدالله علي الاحمري" userId="68cdb2cc-7ab6-4d37-be63-1b932625588b" providerId="ADAL" clId="{1AD040BE-B8FA-E842-A715-AFDF6843583C}"/>
    <pc:docChg chg="undo custSel addSld delSld modSld sldOrd">
      <pc:chgData name="عبدالرحمن عبدالله علي الاحمري" userId="68cdb2cc-7ab6-4d37-be63-1b932625588b" providerId="ADAL" clId="{1AD040BE-B8FA-E842-A715-AFDF6843583C}" dt="2025-11-15T07:13:13.802" v="151"/>
      <pc:docMkLst>
        <pc:docMk/>
      </pc:docMkLst>
      <pc:sldChg chg="delSp modSp mod ord">
        <pc:chgData name="عبدالرحمن عبدالله علي الاحمري" userId="68cdb2cc-7ab6-4d37-be63-1b932625588b" providerId="ADAL" clId="{1AD040BE-B8FA-E842-A715-AFDF6843583C}" dt="2025-11-15T07:13:13.802" v="151"/>
        <pc:sldMkLst>
          <pc:docMk/>
          <pc:sldMk cId="1955418579" sldId="257"/>
        </pc:sldMkLst>
        <pc:spChg chg="mod">
          <ac:chgData name="عبدالرحمن عبدالله علي الاحمري" userId="68cdb2cc-7ab6-4d37-be63-1b932625588b" providerId="ADAL" clId="{1AD040BE-B8FA-E842-A715-AFDF6843583C}" dt="2025-11-15T07:13:13.802" v="151"/>
          <ac:spMkLst>
            <pc:docMk/>
            <pc:sldMk cId="1955418579" sldId="257"/>
            <ac:spMk id="3" creationId="{7892022D-E36A-1AFA-4834-85E1DF12BAC9}"/>
          </ac:spMkLst>
        </pc:spChg>
        <pc:spChg chg="mod">
          <ac:chgData name="عبدالرحمن عبدالله علي الاحمري" userId="68cdb2cc-7ab6-4d37-be63-1b932625588b" providerId="ADAL" clId="{1AD040BE-B8FA-E842-A715-AFDF6843583C}" dt="2025-11-15T07:13:13.802" v="151"/>
          <ac:spMkLst>
            <pc:docMk/>
            <pc:sldMk cId="1955418579" sldId="257"/>
            <ac:spMk id="8" creationId="{DE7D5410-C6B7-17EF-04BB-718DBCAA88E0}"/>
          </ac:spMkLst>
        </pc:spChg>
        <pc:spChg chg="del">
          <ac:chgData name="عبدالرحمن عبدالله علي الاحمري" userId="68cdb2cc-7ab6-4d37-be63-1b932625588b" providerId="ADAL" clId="{1AD040BE-B8FA-E842-A715-AFDF6843583C}" dt="2025-10-16T22:26:54.072" v="26" actId="478"/>
          <ac:spMkLst>
            <pc:docMk/>
            <pc:sldMk cId="1955418579" sldId="257"/>
            <ac:spMk id="12" creationId="{69E13DCB-CDC4-80AF-3349-8D0D17E14A01}"/>
          </ac:spMkLst>
        </pc:spChg>
        <pc:spChg chg="mod">
          <ac:chgData name="عبدالرحمن عبدالله علي الاحمري" userId="68cdb2cc-7ab6-4d37-be63-1b932625588b" providerId="ADAL" clId="{1AD040BE-B8FA-E842-A715-AFDF6843583C}" dt="2025-10-16T22:27:00.623" v="27" actId="1076"/>
          <ac:spMkLst>
            <pc:docMk/>
            <pc:sldMk cId="1955418579" sldId="257"/>
            <ac:spMk id="27" creationId="{05F7EE7D-EB7B-64BD-056D-D4F21E95B482}"/>
          </ac:spMkLst>
        </pc:spChg>
        <pc:spChg chg="del">
          <ac:chgData name="عبدالرحمن عبدالله علي الاحمري" userId="68cdb2cc-7ab6-4d37-be63-1b932625588b" providerId="ADAL" clId="{1AD040BE-B8FA-E842-A715-AFDF6843583C}" dt="2025-10-16T22:26:54.072" v="26" actId="478"/>
          <ac:spMkLst>
            <pc:docMk/>
            <pc:sldMk cId="1955418579" sldId="257"/>
            <ac:spMk id="28" creationId="{C80CD8CC-7409-9999-BA31-A323C900FB7E}"/>
          </ac:spMkLst>
        </pc:spChg>
        <pc:picChg chg="mod">
          <ac:chgData name="عبدالرحمن عبدالله علي الاحمري" userId="68cdb2cc-7ab6-4d37-be63-1b932625588b" providerId="ADAL" clId="{1AD040BE-B8FA-E842-A715-AFDF6843583C}" dt="2025-10-16T22:27:03.743" v="28" actId="1076"/>
          <ac:picMkLst>
            <pc:docMk/>
            <pc:sldMk cId="1955418579" sldId="257"/>
            <ac:picMk id="11" creationId="{D05A295C-70A2-6E46-1B19-AA2401E5AE14}"/>
          </ac:picMkLst>
        </pc:picChg>
        <pc:picChg chg="del">
          <ac:chgData name="عبدالرحمن عبدالله علي الاحمري" userId="68cdb2cc-7ab6-4d37-be63-1b932625588b" providerId="ADAL" clId="{1AD040BE-B8FA-E842-A715-AFDF6843583C}" dt="2025-10-16T22:26:19.152" v="19" actId="478"/>
          <ac:picMkLst>
            <pc:docMk/>
            <pc:sldMk cId="1955418579" sldId="257"/>
            <ac:picMk id="18" creationId="{F7273B98-BF85-B295-63E5-0DB40E294FE1}"/>
          </ac:picMkLst>
        </pc:picChg>
        <pc:picChg chg="mod">
          <ac:chgData name="عبدالرحمن عبدالله علي الاحمري" userId="68cdb2cc-7ab6-4d37-be63-1b932625588b" providerId="ADAL" clId="{1AD040BE-B8FA-E842-A715-AFDF6843583C}" dt="2025-10-16T22:27:07.513" v="29" actId="1076"/>
          <ac:picMkLst>
            <pc:docMk/>
            <pc:sldMk cId="1955418579" sldId="257"/>
            <ac:picMk id="19" creationId="{4D4330D7-30BD-1719-B711-593DC0AC77D5}"/>
          </ac:picMkLst>
        </pc:picChg>
        <pc:picChg chg="del">
          <ac:chgData name="عبدالرحمن عبدالله علي الاحمري" userId="68cdb2cc-7ab6-4d37-be63-1b932625588b" providerId="ADAL" clId="{1AD040BE-B8FA-E842-A715-AFDF6843583C}" dt="2025-10-16T22:26:20.389" v="20" actId="478"/>
          <ac:picMkLst>
            <pc:docMk/>
            <pc:sldMk cId="1955418579" sldId="257"/>
            <ac:picMk id="21" creationId="{7A4312B6-697B-EF21-6783-E96345A3570E}"/>
          </ac:picMkLst>
        </pc:picChg>
      </pc:sldChg>
      <pc:sldChg chg="delSp modSp mod">
        <pc:chgData name="عبدالرحمن عبدالله علي الاحمري" userId="68cdb2cc-7ab6-4d37-be63-1b932625588b" providerId="ADAL" clId="{1AD040BE-B8FA-E842-A715-AFDF6843583C}" dt="2025-11-15T07:13:13.802" v="151"/>
        <pc:sldMkLst>
          <pc:docMk/>
          <pc:sldMk cId="515839799" sldId="262"/>
        </pc:sldMkLst>
        <pc:spChg chg="mod">
          <ac:chgData name="عبدالرحمن عبدالله علي الاحمري" userId="68cdb2cc-7ab6-4d37-be63-1b932625588b" providerId="ADAL" clId="{1AD040BE-B8FA-E842-A715-AFDF6843583C}" dt="2025-11-15T07:13:13.802" v="151"/>
          <ac:spMkLst>
            <pc:docMk/>
            <pc:sldMk cId="515839799" sldId="262"/>
            <ac:spMk id="3" creationId="{A072EEA4-2C68-EFC7-71AE-56DD49B78AEC}"/>
          </ac:spMkLst>
        </pc:spChg>
        <pc:spChg chg="mod">
          <ac:chgData name="عبدالرحمن عبدالله علي الاحمري" userId="68cdb2cc-7ab6-4d37-be63-1b932625588b" providerId="ADAL" clId="{1AD040BE-B8FA-E842-A715-AFDF6843583C}" dt="2025-11-15T07:13:13.802" v="151"/>
          <ac:spMkLst>
            <pc:docMk/>
            <pc:sldMk cId="515839799" sldId="262"/>
            <ac:spMk id="8" creationId="{DE7D5410-C6B7-17EF-04BB-718DBCAA88E0}"/>
          </ac:spMkLst>
        </pc:spChg>
        <pc:spChg chg="del">
          <ac:chgData name="عبدالرحمن عبدالله علي الاحمري" userId="68cdb2cc-7ab6-4d37-be63-1b932625588b" providerId="ADAL" clId="{1AD040BE-B8FA-E842-A715-AFDF6843583C}" dt="2025-10-16T22:25:11.146" v="6" actId="478"/>
          <ac:spMkLst>
            <pc:docMk/>
            <pc:sldMk cId="515839799" sldId="262"/>
            <ac:spMk id="9" creationId="{4191F70E-4040-75CB-6D5C-D414A5F7C985}"/>
          </ac:spMkLst>
        </pc:spChg>
        <pc:spChg chg="del">
          <ac:chgData name="عبدالرحمن عبدالله علي الاحمري" userId="68cdb2cc-7ab6-4d37-be63-1b932625588b" providerId="ADAL" clId="{1AD040BE-B8FA-E842-A715-AFDF6843583C}" dt="2025-10-16T22:25:03.534" v="5" actId="478"/>
          <ac:spMkLst>
            <pc:docMk/>
            <pc:sldMk cId="515839799" sldId="262"/>
            <ac:spMk id="22" creationId="{582C4D91-A716-71CE-D797-664D5B049ADA}"/>
          </ac:spMkLst>
        </pc:spChg>
        <pc:spChg chg="del">
          <ac:chgData name="عبدالرحمن عبدالله علي الاحمري" userId="68cdb2cc-7ab6-4d37-be63-1b932625588b" providerId="ADAL" clId="{1AD040BE-B8FA-E842-A715-AFDF6843583C}" dt="2025-10-16T22:24:56.608" v="3" actId="478"/>
          <ac:spMkLst>
            <pc:docMk/>
            <pc:sldMk cId="515839799" sldId="262"/>
            <ac:spMk id="24" creationId="{22944F66-912E-62BB-CB93-CC4219CBC352}"/>
          </ac:spMkLst>
        </pc:spChg>
        <pc:picChg chg="mod">
          <ac:chgData name="عبدالرحمن عبدالله علي الاحمري" userId="68cdb2cc-7ab6-4d37-be63-1b932625588b" providerId="ADAL" clId="{1AD040BE-B8FA-E842-A715-AFDF6843583C}" dt="2025-10-16T22:25:00.601" v="4" actId="14100"/>
          <ac:picMkLst>
            <pc:docMk/>
            <pc:sldMk cId="515839799" sldId="262"/>
            <ac:picMk id="15" creationId="{FA2FFAC0-52FE-7F4A-FC42-83655448921A}"/>
          </ac:picMkLst>
        </pc:picChg>
        <pc:picChg chg="del">
          <ac:chgData name="عبدالرحمن عبدالله علي الاحمري" userId="68cdb2cc-7ab6-4d37-be63-1b932625588b" providerId="ADAL" clId="{1AD040BE-B8FA-E842-A715-AFDF6843583C}" dt="2025-10-16T22:24:17.500" v="0" actId="478"/>
          <ac:picMkLst>
            <pc:docMk/>
            <pc:sldMk cId="515839799" sldId="262"/>
            <ac:picMk id="17" creationId="{8A341FED-AC31-8975-977E-124F387B6A07}"/>
          </ac:picMkLst>
        </pc:picChg>
        <pc:picChg chg="del">
          <ac:chgData name="عبدالرحمن عبدالله علي الاحمري" userId="68cdb2cc-7ab6-4d37-be63-1b932625588b" providerId="ADAL" clId="{1AD040BE-B8FA-E842-A715-AFDF6843583C}" dt="2025-10-16T22:24:25.798" v="2" actId="478"/>
          <ac:picMkLst>
            <pc:docMk/>
            <pc:sldMk cId="515839799" sldId="262"/>
            <ac:picMk id="21" creationId="{6B15C4DA-E798-C030-A169-A98EBE2869DA}"/>
          </ac:picMkLst>
        </pc:picChg>
      </pc:sldChg>
      <pc:sldChg chg="del">
        <pc:chgData name="عبدالرحمن عبدالله علي الاحمري" userId="68cdb2cc-7ab6-4d37-be63-1b932625588b" providerId="ADAL" clId="{1AD040BE-B8FA-E842-A715-AFDF6843583C}" dt="2025-10-16T22:30:42.818" v="47" actId="2696"/>
        <pc:sldMkLst>
          <pc:docMk/>
          <pc:sldMk cId="832974315" sldId="272"/>
        </pc:sldMkLst>
      </pc:sldChg>
      <pc:sldChg chg="modSp mod ord">
        <pc:chgData name="عبدالرحمن عبدالله علي الاحمري" userId="68cdb2cc-7ab6-4d37-be63-1b932625588b" providerId="ADAL" clId="{1AD040BE-B8FA-E842-A715-AFDF6843583C}" dt="2025-11-15T07:13:13.802" v="151"/>
        <pc:sldMkLst>
          <pc:docMk/>
          <pc:sldMk cId="4165040194" sldId="276"/>
        </pc:sldMkLst>
        <pc:spChg chg="mod">
          <ac:chgData name="عبدالرحمن عبدالله علي الاحمري" userId="68cdb2cc-7ab6-4d37-be63-1b932625588b" providerId="ADAL" clId="{1AD040BE-B8FA-E842-A715-AFDF6843583C}" dt="2025-11-15T07:13:13.802" v="151"/>
          <ac:spMkLst>
            <pc:docMk/>
            <pc:sldMk cId="4165040194" sldId="276"/>
            <ac:spMk id="8" creationId="{DE7D5410-C6B7-17EF-04BB-718DBCAA88E0}"/>
          </ac:spMkLst>
        </pc:spChg>
        <pc:spChg chg="mod">
          <ac:chgData name="عبدالرحمن عبدالله علي الاحمري" userId="68cdb2cc-7ab6-4d37-be63-1b932625588b" providerId="ADAL" clId="{1AD040BE-B8FA-E842-A715-AFDF6843583C}" dt="2025-11-15T07:13:13.802" v="151"/>
          <ac:spMkLst>
            <pc:docMk/>
            <pc:sldMk cId="4165040194" sldId="276"/>
            <ac:spMk id="12" creationId="{10EB0E06-2508-8D53-15BD-138270852712}"/>
          </ac:spMkLst>
        </pc:spChg>
      </pc:sldChg>
      <pc:sldChg chg="addSp delSp modSp add mod">
        <pc:chgData name="عبدالرحمن عبدالله علي الاحمري" userId="68cdb2cc-7ab6-4d37-be63-1b932625588b" providerId="ADAL" clId="{1AD040BE-B8FA-E842-A715-AFDF6843583C}" dt="2025-11-15T07:13:13.802" v="151"/>
        <pc:sldMkLst>
          <pc:docMk/>
          <pc:sldMk cId="3107436618" sldId="277"/>
        </pc:sldMkLst>
        <pc:spChg chg="mod">
          <ac:chgData name="عبدالرحمن عبدالله علي الاحمري" userId="68cdb2cc-7ab6-4d37-be63-1b932625588b" providerId="ADAL" clId="{1AD040BE-B8FA-E842-A715-AFDF6843583C}" dt="2025-11-15T07:13:13.802" v="151"/>
          <ac:spMkLst>
            <pc:docMk/>
            <pc:sldMk cId="3107436618" sldId="277"/>
            <ac:spMk id="3" creationId="{7892022D-E36A-1AFA-4834-85E1DF12BAC9}"/>
          </ac:spMkLst>
        </pc:spChg>
        <pc:spChg chg="mod">
          <ac:chgData name="عبدالرحمن عبدالله علي الاحمري" userId="68cdb2cc-7ab6-4d37-be63-1b932625588b" providerId="ADAL" clId="{1AD040BE-B8FA-E842-A715-AFDF6843583C}" dt="2025-11-15T07:13:13.802" v="151"/>
          <ac:spMkLst>
            <pc:docMk/>
            <pc:sldMk cId="3107436618" sldId="277"/>
            <ac:spMk id="8" creationId="{DE7D5410-C6B7-17EF-04BB-718DBCAA88E0}"/>
          </ac:spMkLst>
        </pc:spChg>
        <pc:spChg chg="mod">
          <ac:chgData name="عبدالرحمن عبدالله علي الاحمري" userId="68cdb2cc-7ab6-4d37-be63-1b932625588b" providerId="ADAL" clId="{1AD040BE-B8FA-E842-A715-AFDF6843583C}" dt="2025-11-14T07:51:45.057" v="82" actId="1037"/>
          <ac:spMkLst>
            <pc:docMk/>
            <pc:sldMk cId="3107436618" sldId="277"/>
            <ac:spMk id="9" creationId="{4191F70E-4040-75CB-6D5C-D414A5F7C985}"/>
          </ac:spMkLst>
        </pc:spChg>
        <pc:spChg chg="mod">
          <ac:chgData name="عبدالرحمن عبدالله علي الاحمري" userId="68cdb2cc-7ab6-4d37-be63-1b932625588b" providerId="ADAL" clId="{1AD040BE-B8FA-E842-A715-AFDF6843583C}" dt="2025-11-14T07:51:45.057" v="82" actId="1037"/>
          <ac:spMkLst>
            <pc:docMk/>
            <pc:sldMk cId="3107436618" sldId="277"/>
            <ac:spMk id="27" creationId="{05F7EE7D-EB7B-64BD-056D-D4F21E95B482}"/>
          </ac:spMkLst>
        </pc:spChg>
        <pc:picChg chg="add mod">
          <ac:chgData name="عبدالرحمن عبدالله علي الاحمري" userId="68cdb2cc-7ab6-4d37-be63-1b932625588b" providerId="ADAL" clId="{1AD040BE-B8FA-E842-A715-AFDF6843583C}" dt="2025-11-14T07:51:45.057" v="82" actId="1037"/>
          <ac:picMkLst>
            <pc:docMk/>
            <pc:sldMk cId="3107436618" sldId="277"/>
            <ac:picMk id="4" creationId="{1C0F22D7-2ADC-4CCB-BEF5-EFF8E0C0A923}"/>
          </ac:picMkLst>
        </pc:picChg>
        <pc:picChg chg="add mod">
          <ac:chgData name="عبدالرحمن عبدالله علي الاحمري" userId="68cdb2cc-7ab6-4d37-be63-1b932625588b" providerId="ADAL" clId="{1AD040BE-B8FA-E842-A715-AFDF6843583C}" dt="2025-11-14T07:51:45.057" v="82" actId="1037"/>
          <ac:picMkLst>
            <pc:docMk/>
            <pc:sldMk cId="3107436618" sldId="277"/>
            <ac:picMk id="6" creationId="{37D6F936-1D93-8DAF-FCA9-82BD6A83482D}"/>
          </ac:picMkLst>
        </pc:picChg>
        <pc:picChg chg="del">
          <ac:chgData name="عبدالرحمن عبدالله علي الاحمري" userId="68cdb2cc-7ab6-4d37-be63-1b932625588b" providerId="ADAL" clId="{1AD040BE-B8FA-E842-A715-AFDF6843583C}" dt="2025-11-14T07:50:05.945" v="63" actId="478"/>
          <ac:picMkLst>
            <pc:docMk/>
            <pc:sldMk cId="3107436618" sldId="277"/>
            <ac:picMk id="11" creationId="{D05A295C-70A2-6E46-1B19-AA2401E5AE14}"/>
          </ac:picMkLst>
        </pc:picChg>
        <pc:picChg chg="del">
          <ac:chgData name="عبدالرحمن عبدالله علي الاحمري" userId="68cdb2cc-7ab6-4d37-be63-1b932625588b" providerId="ADAL" clId="{1AD040BE-B8FA-E842-A715-AFDF6843583C}" dt="2025-11-14T07:50:07.523" v="64" actId="478"/>
          <ac:picMkLst>
            <pc:docMk/>
            <pc:sldMk cId="3107436618" sldId="277"/>
            <ac:picMk id="19" creationId="{4D4330D7-30BD-1719-B711-593DC0AC77D5}"/>
          </ac:picMkLst>
        </pc:picChg>
      </pc:sldChg>
    </pc:docChg>
  </pc:docChgLst>
  <pc:docChgLst>
    <pc:chgData name="عبدالرحمن عبدالله علي الاحمري" userId="68cdb2cc-7ab6-4d37-be63-1b932625588b" providerId="ADAL" clId="{6C6F7454-9AC2-0C4D-8194-14912903BDE4}"/>
    <pc:docChg chg="undo custSel delSld modSld">
      <pc:chgData name="عبدالرحمن عبدالله علي الاحمري" userId="68cdb2cc-7ab6-4d37-be63-1b932625588b" providerId="ADAL" clId="{6C6F7454-9AC2-0C4D-8194-14912903BDE4}" dt="2025-07-11T23:58:43.281" v="185" actId="1036"/>
      <pc:docMkLst>
        <pc:docMk/>
      </pc:docMkLst>
      <pc:sldChg chg="addSp modSp mod">
        <pc:chgData name="عبدالرحمن عبدالله علي الاحمري" userId="68cdb2cc-7ab6-4d37-be63-1b932625588b" providerId="ADAL" clId="{6C6F7454-9AC2-0C4D-8194-14912903BDE4}" dt="2025-07-11T23:56:42.270" v="115" actId="404"/>
        <pc:sldMkLst>
          <pc:docMk/>
          <pc:sldMk cId="1955418579" sldId="257"/>
        </pc:sldMkLst>
        <pc:spChg chg="add mod">
          <ac:chgData name="عبدالرحمن عبدالله علي الاحمري" userId="68cdb2cc-7ab6-4d37-be63-1b932625588b" providerId="ADAL" clId="{6C6F7454-9AC2-0C4D-8194-14912903BDE4}" dt="2025-07-11T23:56:42.270" v="115" actId="404"/>
          <ac:spMkLst>
            <pc:docMk/>
            <pc:sldMk cId="1955418579" sldId="257"/>
            <ac:spMk id="3" creationId="{7892022D-E36A-1AFA-4834-85E1DF12BAC9}"/>
          </ac:spMkLst>
        </pc:spChg>
      </pc:sldChg>
      <pc:sldChg chg="del">
        <pc:chgData name="عبدالرحمن عبدالله علي الاحمري" userId="68cdb2cc-7ab6-4d37-be63-1b932625588b" providerId="ADAL" clId="{6C6F7454-9AC2-0C4D-8194-14912903BDE4}" dt="2025-07-11T18:20:32.403" v="1" actId="2696"/>
        <pc:sldMkLst>
          <pc:docMk/>
          <pc:sldMk cId="1206175369" sldId="258"/>
        </pc:sldMkLst>
      </pc:sldChg>
      <pc:sldChg chg="addSp modSp mod">
        <pc:chgData name="عبدالرحمن عبدالله علي الاحمري" userId="68cdb2cc-7ab6-4d37-be63-1b932625588b" providerId="ADAL" clId="{6C6F7454-9AC2-0C4D-8194-14912903BDE4}" dt="2025-07-11T23:56:52.229" v="117" actId="404"/>
        <pc:sldMkLst>
          <pc:docMk/>
          <pc:sldMk cId="515839799" sldId="262"/>
        </pc:sldMkLst>
        <pc:spChg chg="add mod">
          <ac:chgData name="عبدالرحمن عبدالله علي الاحمري" userId="68cdb2cc-7ab6-4d37-be63-1b932625588b" providerId="ADAL" clId="{6C6F7454-9AC2-0C4D-8194-14912903BDE4}" dt="2025-07-11T23:56:52.229" v="117" actId="404"/>
          <ac:spMkLst>
            <pc:docMk/>
            <pc:sldMk cId="515839799" sldId="262"/>
            <ac:spMk id="3" creationId="{A072EEA4-2C68-EFC7-71AE-56DD49B78AEC}"/>
          </ac:spMkLst>
        </pc:spChg>
      </pc:sldChg>
      <pc:sldChg chg="del">
        <pc:chgData name="عبدالرحمن عبدالله علي الاحمري" userId="68cdb2cc-7ab6-4d37-be63-1b932625588b" providerId="ADAL" clId="{6C6F7454-9AC2-0C4D-8194-14912903BDE4}" dt="2025-07-11T18:20:37.100" v="2" actId="2696"/>
        <pc:sldMkLst>
          <pc:docMk/>
          <pc:sldMk cId="2112321017" sldId="264"/>
        </pc:sldMkLst>
      </pc:sldChg>
      <pc:sldChg chg="addSp delSp modSp mod">
        <pc:chgData name="عبدالرحمن عبدالله علي الاحمري" userId="68cdb2cc-7ab6-4d37-be63-1b932625588b" providerId="ADAL" clId="{6C6F7454-9AC2-0C4D-8194-14912903BDE4}" dt="2025-07-11T23:58:32.117" v="174" actId="1035"/>
        <pc:sldMkLst>
          <pc:docMk/>
          <pc:sldMk cId="565855428" sldId="265"/>
        </pc:sldMkLst>
        <pc:spChg chg="add mod">
          <ac:chgData name="عبدالرحمن عبدالله علي الاحمري" userId="68cdb2cc-7ab6-4d37-be63-1b932625588b" providerId="ADAL" clId="{6C6F7454-9AC2-0C4D-8194-14912903BDE4}" dt="2025-07-11T23:58:32.117" v="174" actId="1035"/>
          <ac:spMkLst>
            <pc:docMk/>
            <pc:sldMk cId="565855428" sldId="265"/>
            <ac:spMk id="4" creationId="{5B936F98-2448-7893-82D1-44F231BC7083}"/>
          </ac:spMkLst>
        </pc:spChg>
        <pc:spChg chg="del">
          <ac:chgData name="عبدالرحمن عبدالله علي الاحمري" userId="68cdb2cc-7ab6-4d37-be63-1b932625588b" providerId="ADAL" clId="{6C6F7454-9AC2-0C4D-8194-14912903BDE4}" dt="2025-07-11T18:21:01.035" v="5" actId="478"/>
          <ac:spMkLst>
            <pc:docMk/>
            <pc:sldMk cId="565855428" sldId="265"/>
            <ac:spMk id="4" creationId="{DAC2A389-2514-9415-175F-A76B6BE70979}"/>
          </ac:spMkLst>
        </pc:spChg>
        <pc:spChg chg="add del">
          <ac:chgData name="عبدالرحمن عبدالله علي الاحمري" userId="68cdb2cc-7ab6-4d37-be63-1b932625588b" providerId="ADAL" clId="{6C6F7454-9AC2-0C4D-8194-14912903BDE4}" dt="2025-07-11T23:57:57.668" v="126" actId="22"/>
          <ac:spMkLst>
            <pc:docMk/>
            <pc:sldMk cId="565855428" sldId="265"/>
            <ac:spMk id="6" creationId="{C90EC271-73AD-BA9E-E537-60F4BAE2BE51}"/>
          </ac:spMkLst>
        </pc:spChg>
        <pc:spChg chg="del">
          <ac:chgData name="عبدالرحمن عبدالله علي الاحمري" userId="68cdb2cc-7ab6-4d37-be63-1b932625588b" providerId="ADAL" clId="{6C6F7454-9AC2-0C4D-8194-14912903BDE4}" dt="2025-07-11T23:58:26.459" v="160" actId="478"/>
          <ac:spMkLst>
            <pc:docMk/>
            <pc:sldMk cId="565855428" sldId="265"/>
            <ac:spMk id="9" creationId="{4191F70E-4040-75CB-6D5C-D414A5F7C985}"/>
          </ac:spMkLst>
        </pc:spChg>
        <pc:graphicFrameChg chg="del">
          <ac:chgData name="عبدالرحمن عبدالله علي الاحمري" userId="68cdb2cc-7ab6-4d37-be63-1b932625588b" providerId="ADAL" clId="{6C6F7454-9AC2-0C4D-8194-14912903BDE4}" dt="2025-07-11T23:58:13.014" v="129" actId="478"/>
          <ac:graphicFrameMkLst>
            <pc:docMk/>
            <pc:sldMk cId="565855428" sldId="265"/>
            <ac:graphicFrameMk id="2" creationId="{75C08485-79F1-D4E4-09E5-A65F44D9CCF4}"/>
          </ac:graphicFrameMkLst>
        </pc:graphicFrameChg>
        <pc:graphicFrameChg chg="add mod">
          <ac:chgData name="عبدالرحمن عبدالله علي الاحمري" userId="68cdb2cc-7ab6-4d37-be63-1b932625588b" providerId="ADAL" clId="{6C6F7454-9AC2-0C4D-8194-14912903BDE4}" dt="2025-07-11T23:58:29.483" v="168" actId="1035"/>
          <ac:graphicFrameMkLst>
            <pc:docMk/>
            <pc:sldMk cId="565855428" sldId="265"/>
            <ac:graphicFrameMk id="7" creationId="{872103A7-C434-A4A0-A435-7E6671FC1428}"/>
          </ac:graphicFrameMkLst>
        </pc:graphicFrameChg>
      </pc:sldChg>
      <pc:sldChg chg="del">
        <pc:chgData name="عبدالرحمن عبدالله علي الاحمري" userId="68cdb2cc-7ab6-4d37-be63-1b932625588b" providerId="ADAL" clId="{6C6F7454-9AC2-0C4D-8194-14912903BDE4}" dt="2025-07-11T18:20:40.183" v="3" actId="2696"/>
        <pc:sldMkLst>
          <pc:docMk/>
          <pc:sldMk cId="1312709298" sldId="268"/>
        </pc:sldMkLst>
      </pc:sldChg>
      <pc:sldChg chg="del">
        <pc:chgData name="عبدالرحمن عبدالله علي الاحمري" userId="68cdb2cc-7ab6-4d37-be63-1b932625588b" providerId="ADAL" clId="{6C6F7454-9AC2-0C4D-8194-14912903BDE4}" dt="2025-07-11T18:20:31.204" v="0" actId="2696"/>
        <pc:sldMkLst>
          <pc:docMk/>
          <pc:sldMk cId="3749976387" sldId="269"/>
        </pc:sldMkLst>
      </pc:sldChg>
      <pc:sldChg chg="del">
        <pc:chgData name="عبدالرحمن عبدالله علي الاحمري" userId="68cdb2cc-7ab6-4d37-be63-1b932625588b" providerId="ADAL" clId="{6C6F7454-9AC2-0C4D-8194-14912903BDE4}" dt="2025-07-11T18:20:41.108" v="4" actId="2696"/>
        <pc:sldMkLst>
          <pc:docMk/>
          <pc:sldMk cId="847292447" sldId="270"/>
        </pc:sldMkLst>
      </pc:sldChg>
      <pc:sldChg chg="addSp modSp mod">
        <pc:chgData name="عبدالرحمن عبدالله علي الاحمري" userId="68cdb2cc-7ab6-4d37-be63-1b932625588b" providerId="ADAL" clId="{6C6F7454-9AC2-0C4D-8194-14912903BDE4}" dt="2025-07-11T23:58:43.281" v="185" actId="1036"/>
        <pc:sldMkLst>
          <pc:docMk/>
          <pc:sldMk cId="832974315" sldId="272"/>
        </pc:sldMkLst>
        <pc:spChg chg="add mod">
          <ac:chgData name="عبدالرحمن عبدالله علي الاحمري" userId="68cdb2cc-7ab6-4d37-be63-1b932625588b" providerId="ADAL" clId="{6C6F7454-9AC2-0C4D-8194-14912903BDE4}" dt="2025-07-11T23:58:43.281" v="185" actId="1036"/>
          <ac:spMkLst>
            <pc:docMk/>
            <pc:sldMk cId="832974315" sldId="272"/>
            <ac:spMk id="5" creationId="{0E73B1F3-B8C1-B734-9F5D-F73E2C2D1B4B}"/>
          </ac:spMkLst>
        </pc:spChg>
        <pc:picChg chg="mod">
          <ac:chgData name="عبدالرحمن عبدالله علي الاحمري" userId="68cdb2cc-7ab6-4d37-be63-1b932625588b" providerId="ADAL" clId="{6C6F7454-9AC2-0C4D-8194-14912903BDE4}" dt="2025-07-11T23:58:39.970" v="181" actId="1036"/>
          <ac:picMkLst>
            <pc:docMk/>
            <pc:sldMk cId="832974315" sldId="272"/>
            <ac:picMk id="3" creationId="{90371FA6-3541-BBC4-2CB2-0CB35E03C301}"/>
          </ac:picMkLst>
        </pc:picChg>
      </pc:sldChg>
      <pc:sldChg chg="addSp modSp mod">
        <pc:chgData name="عبدالرحمن عبدالله علي الاحمري" userId="68cdb2cc-7ab6-4d37-be63-1b932625588b" providerId="ADAL" clId="{6C6F7454-9AC2-0C4D-8194-14912903BDE4}" dt="2025-07-11T23:56:57.590" v="118" actId="404"/>
        <pc:sldMkLst>
          <pc:docMk/>
          <pc:sldMk cId="3340310432" sldId="273"/>
        </pc:sldMkLst>
        <pc:spChg chg="add mod">
          <ac:chgData name="عبدالرحمن عبدالله علي الاحمري" userId="68cdb2cc-7ab6-4d37-be63-1b932625588b" providerId="ADAL" clId="{6C6F7454-9AC2-0C4D-8194-14912903BDE4}" dt="2025-07-11T23:56:57.590" v="118" actId="404"/>
          <ac:spMkLst>
            <pc:docMk/>
            <pc:sldMk cId="3340310432" sldId="273"/>
            <ac:spMk id="5" creationId="{0093E402-2A53-5206-F893-E5101F892BA6}"/>
          </ac:spMkLst>
        </pc:spChg>
        <pc:graphicFrameChg chg="mod">
          <ac:chgData name="عبدالرحمن عبدالله علي الاحمري" userId="68cdb2cc-7ab6-4d37-be63-1b932625588b" providerId="ADAL" clId="{6C6F7454-9AC2-0C4D-8194-14912903BDE4}" dt="2025-07-11T23:53:38.218" v="32" actId="1036"/>
          <ac:graphicFrameMkLst>
            <pc:docMk/>
            <pc:sldMk cId="3340310432" sldId="273"/>
            <ac:graphicFrameMk id="3" creationId="{D679569F-5135-A7DE-82E8-622200FD13F0}"/>
          </ac:graphicFrameMkLst>
        </pc:graphicFrameChg>
      </pc:sldChg>
      <pc:sldChg chg="addSp modSp mod">
        <pc:chgData name="عبدالرحمن عبدالله علي الاحمري" userId="68cdb2cc-7ab6-4d37-be63-1b932625588b" providerId="ADAL" clId="{6C6F7454-9AC2-0C4D-8194-14912903BDE4}" dt="2025-07-11T23:56:34.914" v="114" actId="1037"/>
        <pc:sldMkLst>
          <pc:docMk/>
          <pc:sldMk cId="4165040194" sldId="276"/>
        </pc:sldMkLst>
        <pc:spChg chg="mod">
          <ac:chgData name="عبدالرحمن عبدالله علي الاحمري" userId="68cdb2cc-7ab6-4d37-be63-1b932625588b" providerId="ADAL" clId="{6C6F7454-9AC2-0C4D-8194-14912903BDE4}" dt="2025-07-11T23:56:04.392" v="100" actId="1035"/>
          <ac:spMkLst>
            <pc:docMk/>
            <pc:sldMk cId="4165040194" sldId="276"/>
            <ac:spMk id="3" creationId="{4AF8FD2D-29A2-872F-67BD-A691BAF116AF}"/>
          </ac:spMkLst>
        </pc:spChg>
        <pc:spChg chg="mod">
          <ac:chgData name="عبدالرحمن عبدالله علي الاحمري" userId="68cdb2cc-7ab6-4d37-be63-1b932625588b" providerId="ADAL" clId="{6C6F7454-9AC2-0C4D-8194-14912903BDE4}" dt="2025-07-11T23:56:08.155" v="104" actId="1036"/>
          <ac:spMkLst>
            <pc:docMk/>
            <pc:sldMk cId="4165040194" sldId="276"/>
            <ac:spMk id="9" creationId="{4191F70E-4040-75CB-6D5C-D414A5F7C985}"/>
          </ac:spMkLst>
        </pc:spChg>
        <pc:spChg chg="add mod">
          <ac:chgData name="عبدالرحمن عبدالله علي الاحمري" userId="68cdb2cc-7ab6-4d37-be63-1b932625588b" providerId="ADAL" clId="{6C6F7454-9AC2-0C4D-8194-14912903BDE4}" dt="2025-07-11T23:56:34.914" v="114" actId="1037"/>
          <ac:spMkLst>
            <pc:docMk/>
            <pc:sldMk cId="4165040194" sldId="276"/>
            <ac:spMk id="12" creationId="{10EB0E06-2508-8D53-15BD-138270852712}"/>
          </ac:spMkLst>
        </pc:spChg>
        <pc:grpChg chg="mod">
          <ac:chgData name="عبدالرحمن عبدالله علي الاحمري" userId="68cdb2cc-7ab6-4d37-be63-1b932625588b" providerId="ADAL" clId="{6C6F7454-9AC2-0C4D-8194-14912903BDE4}" dt="2025-07-11T23:56:04.392" v="100" actId="1035"/>
          <ac:grpSpMkLst>
            <pc:docMk/>
            <pc:sldMk cId="4165040194" sldId="276"/>
            <ac:grpSpMk id="5" creationId="{FE249E27-A5AC-FFDB-88BE-A25CD3CD13E2}"/>
          </ac:grpSpMkLst>
        </pc:grpChg>
        <pc:grpChg chg="mod">
          <ac:chgData name="عبدالرحمن عبدالله علي الاحمري" userId="68cdb2cc-7ab6-4d37-be63-1b932625588b" providerId="ADAL" clId="{6C6F7454-9AC2-0C4D-8194-14912903BDE4}" dt="2025-07-11T23:55:50.390" v="81" actId="1036"/>
          <ac:grpSpMkLst>
            <pc:docMk/>
            <pc:sldMk cId="4165040194" sldId="276"/>
            <ac:grpSpMk id="11" creationId="{FEA265D2-D9CA-AE23-1441-349E4148DA4E}"/>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S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294267-3C4C-E446-8FB3-3EC6002AB9C6}" type="datetimeFigureOut">
              <a:rPr lang="en-SA" smtClean="0"/>
              <a:t>15/11/2025 R</a:t>
            </a:fld>
            <a:endParaRPr lang="en-SA"/>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S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S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EC2FE59-203D-DE4B-B194-EE76ECB2CC05}" type="slidenum">
              <a:rPr lang="en-SA" smtClean="0"/>
              <a:t>‹#›</a:t>
            </a:fld>
            <a:endParaRPr lang="en-SA"/>
          </a:p>
        </p:txBody>
      </p:sp>
    </p:spTree>
    <p:extLst>
      <p:ext uri="{BB962C8B-B14F-4D97-AF65-F5344CB8AC3E}">
        <p14:creationId xmlns:p14="http://schemas.microsoft.com/office/powerpoint/2010/main" val="23636928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49B9BA5-D70A-534C-AD32-8E129A2D690E}" type="slidenum">
              <a:rPr lang="en-SA" smtClean="0"/>
              <a:t>1</a:t>
            </a:fld>
            <a:endParaRPr lang="en-SA"/>
          </a:p>
        </p:txBody>
      </p:sp>
    </p:spTree>
    <p:extLst>
      <p:ext uri="{BB962C8B-B14F-4D97-AF65-F5344CB8AC3E}">
        <p14:creationId xmlns:p14="http://schemas.microsoft.com/office/powerpoint/2010/main" val="6427725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SA" dirty="0"/>
          </a:p>
        </p:txBody>
      </p:sp>
      <p:sp>
        <p:nvSpPr>
          <p:cNvPr id="4" name="Slide Number Placeholder 3"/>
          <p:cNvSpPr>
            <a:spLocks noGrp="1"/>
          </p:cNvSpPr>
          <p:nvPr>
            <p:ph type="sldNum" sz="quarter" idx="5"/>
          </p:nvPr>
        </p:nvSpPr>
        <p:spPr/>
        <p:txBody>
          <a:bodyPr/>
          <a:lstStyle/>
          <a:p>
            <a:fld id="{849B9BA5-D70A-534C-AD32-8E129A2D690E}" type="slidenum">
              <a:rPr lang="en-SA" smtClean="0"/>
              <a:t>2</a:t>
            </a:fld>
            <a:endParaRPr lang="en-SA"/>
          </a:p>
        </p:txBody>
      </p:sp>
    </p:spTree>
    <p:extLst>
      <p:ext uri="{BB962C8B-B14F-4D97-AF65-F5344CB8AC3E}">
        <p14:creationId xmlns:p14="http://schemas.microsoft.com/office/powerpoint/2010/main" val="6740216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SA" dirty="0"/>
          </a:p>
        </p:txBody>
      </p:sp>
      <p:sp>
        <p:nvSpPr>
          <p:cNvPr id="4" name="Slide Number Placeholder 3"/>
          <p:cNvSpPr>
            <a:spLocks noGrp="1"/>
          </p:cNvSpPr>
          <p:nvPr>
            <p:ph type="sldNum" sz="quarter" idx="5"/>
          </p:nvPr>
        </p:nvSpPr>
        <p:spPr/>
        <p:txBody>
          <a:bodyPr/>
          <a:lstStyle/>
          <a:p>
            <a:fld id="{849B9BA5-D70A-534C-AD32-8E129A2D690E}" type="slidenum">
              <a:rPr lang="en-SA" smtClean="0"/>
              <a:t>3</a:t>
            </a:fld>
            <a:endParaRPr lang="en-SA"/>
          </a:p>
        </p:txBody>
      </p:sp>
    </p:spTree>
    <p:extLst>
      <p:ext uri="{BB962C8B-B14F-4D97-AF65-F5344CB8AC3E}">
        <p14:creationId xmlns:p14="http://schemas.microsoft.com/office/powerpoint/2010/main" val="17953214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SA" dirty="0"/>
          </a:p>
        </p:txBody>
      </p:sp>
      <p:sp>
        <p:nvSpPr>
          <p:cNvPr id="4" name="Slide Number Placeholder 3"/>
          <p:cNvSpPr>
            <a:spLocks noGrp="1"/>
          </p:cNvSpPr>
          <p:nvPr>
            <p:ph type="sldNum" sz="quarter" idx="5"/>
          </p:nvPr>
        </p:nvSpPr>
        <p:spPr/>
        <p:txBody>
          <a:bodyPr/>
          <a:lstStyle/>
          <a:p>
            <a:fld id="{849B9BA5-D70A-534C-AD32-8E129A2D690E}" type="slidenum">
              <a:rPr lang="en-SA" smtClean="0"/>
              <a:t>4</a:t>
            </a:fld>
            <a:endParaRPr lang="en-SA"/>
          </a:p>
        </p:txBody>
      </p:sp>
    </p:spTree>
    <p:extLst>
      <p:ext uri="{BB962C8B-B14F-4D97-AF65-F5344CB8AC3E}">
        <p14:creationId xmlns:p14="http://schemas.microsoft.com/office/powerpoint/2010/main" val="18655960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97E1E91-DF44-E34B-9400-88125B7FBE4D}" type="datetimeFigureOut">
              <a:rPr lang="en-SA" smtClean="0"/>
              <a:t>15/11/2025 R</a:t>
            </a:fld>
            <a:endParaRPr lang="en-SA"/>
          </a:p>
        </p:txBody>
      </p:sp>
      <p:sp>
        <p:nvSpPr>
          <p:cNvPr id="5" name="Footer Placeholder 4"/>
          <p:cNvSpPr>
            <a:spLocks noGrp="1"/>
          </p:cNvSpPr>
          <p:nvPr>
            <p:ph type="ftr" sz="quarter" idx="11"/>
          </p:nvPr>
        </p:nvSpPr>
        <p:spPr/>
        <p:txBody>
          <a:bodyPr/>
          <a:lstStyle/>
          <a:p>
            <a:endParaRPr lang="en-SA"/>
          </a:p>
        </p:txBody>
      </p:sp>
      <p:sp>
        <p:nvSpPr>
          <p:cNvPr id="6" name="Slide Number Placeholder 5"/>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11821605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97E1E91-DF44-E34B-9400-88125B7FBE4D}" type="datetimeFigureOut">
              <a:rPr lang="en-SA" smtClean="0"/>
              <a:t>15/11/2025 R</a:t>
            </a:fld>
            <a:endParaRPr lang="en-SA"/>
          </a:p>
        </p:txBody>
      </p:sp>
      <p:sp>
        <p:nvSpPr>
          <p:cNvPr id="5" name="Footer Placeholder 4"/>
          <p:cNvSpPr>
            <a:spLocks noGrp="1"/>
          </p:cNvSpPr>
          <p:nvPr>
            <p:ph type="ftr" sz="quarter" idx="11"/>
          </p:nvPr>
        </p:nvSpPr>
        <p:spPr/>
        <p:txBody>
          <a:bodyPr/>
          <a:lstStyle/>
          <a:p>
            <a:endParaRPr lang="en-SA"/>
          </a:p>
        </p:txBody>
      </p:sp>
      <p:sp>
        <p:nvSpPr>
          <p:cNvPr id="6" name="Slide Number Placeholder 5"/>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29045132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97E1E91-DF44-E34B-9400-88125B7FBE4D}" type="datetimeFigureOut">
              <a:rPr lang="en-SA" smtClean="0"/>
              <a:t>15/11/2025 R</a:t>
            </a:fld>
            <a:endParaRPr lang="en-SA"/>
          </a:p>
        </p:txBody>
      </p:sp>
      <p:sp>
        <p:nvSpPr>
          <p:cNvPr id="5" name="Footer Placeholder 4"/>
          <p:cNvSpPr>
            <a:spLocks noGrp="1"/>
          </p:cNvSpPr>
          <p:nvPr>
            <p:ph type="ftr" sz="quarter" idx="11"/>
          </p:nvPr>
        </p:nvSpPr>
        <p:spPr/>
        <p:txBody>
          <a:bodyPr/>
          <a:lstStyle/>
          <a:p>
            <a:endParaRPr lang="en-SA"/>
          </a:p>
        </p:txBody>
      </p:sp>
      <p:sp>
        <p:nvSpPr>
          <p:cNvPr id="6" name="Slide Number Placeholder 5"/>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1281207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97E1E91-DF44-E34B-9400-88125B7FBE4D}" type="datetimeFigureOut">
              <a:rPr lang="en-SA" smtClean="0"/>
              <a:t>15/11/2025 R</a:t>
            </a:fld>
            <a:endParaRPr lang="en-SA"/>
          </a:p>
        </p:txBody>
      </p:sp>
      <p:sp>
        <p:nvSpPr>
          <p:cNvPr id="5" name="Footer Placeholder 4"/>
          <p:cNvSpPr>
            <a:spLocks noGrp="1"/>
          </p:cNvSpPr>
          <p:nvPr>
            <p:ph type="ftr" sz="quarter" idx="11"/>
          </p:nvPr>
        </p:nvSpPr>
        <p:spPr/>
        <p:txBody>
          <a:bodyPr/>
          <a:lstStyle/>
          <a:p>
            <a:endParaRPr lang="en-SA"/>
          </a:p>
        </p:txBody>
      </p:sp>
      <p:sp>
        <p:nvSpPr>
          <p:cNvPr id="6" name="Slide Number Placeholder 5"/>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36663427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97E1E91-DF44-E34B-9400-88125B7FBE4D}" type="datetimeFigureOut">
              <a:rPr lang="en-SA" smtClean="0"/>
              <a:t>15/11/2025 R</a:t>
            </a:fld>
            <a:endParaRPr lang="en-SA"/>
          </a:p>
        </p:txBody>
      </p:sp>
      <p:sp>
        <p:nvSpPr>
          <p:cNvPr id="5" name="Footer Placeholder 4"/>
          <p:cNvSpPr>
            <a:spLocks noGrp="1"/>
          </p:cNvSpPr>
          <p:nvPr>
            <p:ph type="ftr" sz="quarter" idx="11"/>
          </p:nvPr>
        </p:nvSpPr>
        <p:spPr/>
        <p:txBody>
          <a:bodyPr/>
          <a:lstStyle/>
          <a:p>
            <a:endParaRPr lang="en-SA"/>
          </a:p>
        </p:txBody>
      </p:sp>
      <p:sp>
        <p:nvSpPr>
          <p:cNvPr id="6" name="Slide Number Placeholder 5"/>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30368813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97E1E91-DF44-E34B-9400-88125B7FBE4D}" type="datetimeFigureOut">
              <a:rPr lang="en-SA" smtClean="0"/>
              <a:t>15/11/2025 R</a:t>
            </a:fld>
            <a:endParaRPr lang="en-SA"/>
          </a:p>
        </p:txBody>
      </p:sp>
      <p:sp>
        <p:nvSpPr>
          <p:cNvPr id="6" name="Footer Placeholder 5"/>
          <p:cNvSpPr>
            <a:spLocks noGrp="1"/>
          </p:cNvSpPr>
          <p:nvPr>
            <p:ph type="ftr" sz="quarter" idx="11"/>
          </p:nvPr>
        </p:nvSpPr>
        <p:spPr/>
        <p:txBody>
          <a:bodyPr/>
          <a:lstStyle/>
          <a:p>
            <a:endParaRPr lang="en-SA"/>
          </a:p>
        </p:txBody>
      </p:sp>
      <p:sp>
        <p:nvSpPr>
          <p:cNvPr id="7" name="Slide Number Placeholder 6"/>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12242018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97E1E91-DF44-E34B-9400-88125B7FBE4D}" type="datetimeFigureOut">
              <a:rPr lang="en-SA" smtClean="0"/>
              <a:t>15/11/2025 R</a:t>
            </a:fld>
            <a:endParaRPr lang="en-SA"/>
          </a:p>
        </p:txBody>
      </p:sp>
      <p:sp>
        <p:nvSpPr>
          <p:cNvPr id="8" name="Footer Placeholder 7"/>
          <p:cNvSpPr>
            <a:spLocks noGrp="1"/>
          </p:cNvSpPr>
          <p:nvPr>
            <p:ph type="ftr" sz="quarter" idx="11"/>
          </p:nvPr>
        </p:nvSpPr>
        <p:spPr/>
        <p:txBody>
          <a:bodyPr/>
          <a:lstStyle/>
          <a:p>
            <a:endParaRPr lang="en-SA"/>
          </a:p>
        </p:txBody>
      </p:sp>
      <p:sp>
        <p:nvSpPr>
          <p:cNvPr id="9" name="Slide Number Placeholder 8"/>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28958712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97E1E91-DF44-E34B-9400-88125B7FBE4D}" type="datetimeFigureOut">
              <a:rPr lang="en-SA" smtClean="0"/>
              <a:t>15/11/2025 R</a:t>
            </a:fld>
            <a:endParaRPr lang="en-SA"/>
          </a:p>
        </p:txBody>
      </p:sp>
      <p:sp>
        <p:nvSpPr>
          <p:cNvPr id="4" name="Footer Placeholder 3"/>
          <p:cNvSpPr>
            <a:spLocks noGrp="1"/>
          </p:cNvSpPr>
          <p:nvPr>
            <p:ph type="ftr" sz="quarter" idx="11"/>
          </p:nvPr>
        </p:nvSpPr>
        <p:spPr/>
        <p:txBody>
          <a:bodyPr/>
          <a:lstStyle/>
          <a:p>
            <a:endParaRPr lang="en-SA"/>
          </a:p>
        </p:txBody>
      </p:sp>
      <p:sp>
        <p:nvSpPr>
          <p:cNvPr id="5" name="Slide Number Placeholder 4"/>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15143584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97E1E91-DF44-E34B-9400-88125B7FBE4D}" type="datetimeFigureOut">
              <a:rPr lang="en-SA" smtClean="0"/>
              <a:t>15/11/2025 R</a:t>
            </a:fld>
            <a:endParaRPr lang="en-SA"/>
          </a:p>
        </p:txBody>
      </p:sp>
      <p:sp>
        <p:nvSpPr>
          <p:cNvPr id="3" name="Footer Placeholder 2"/>
          <p:cNvSpPr>
            <a:spLocks noGrp="1"/>
          </p:cNvSpPr>
          <p:nvPr>
            <p:ph type="ftr" sz="quarter" idx="11"/>
          </p:nvPr>
        </p:nvSpPr>
        <p:spPr/>
        <p:txBody>
          <a:bodyPr/>
          <a:lstStyle/>
          <a:p>
            <a:endParaRPr lang="en-SA"/>
          </a:p>
        </p:txBody>
      </p:sp>
      <p:sp>
        <p:nvSpPr>
          <p:cNvPr id="4" name="Slide Number Placeholder 3"/>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17557278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97E1E91-DF44-E34B-9400-88125B7FBE4D}" type="datetimeFigureOut">
              <a:rPr lang="en-SA" smtClean="0"/>
              <a:t>15/11/2025 R</a:t>
            </a:fld>
            <a:endParaRPr lang="en-SA"/>
          </a:p>
        </p:txBody>
      </p:sp>
      <p:sp>
        <p:nvSpPr>
          <p:cNvPr id="6" name="Footer Placeholder 5"/>
          <p:cNvSpPr>
            <a:spLocks noGrp="1"/>
          </p:cNvSpPr>
          <p:nvPr>
            <p:ph type="ftr" sz="quarter" idx="11"/>
          </p:nvPr>
        </p:nvSpPr>
        <p:spPr/>
        <p:txBody>
          <a:bodyPr/>
          <a:lstStyle/>
          <a:p>
            <a:endParaRPr lang="en-SA"/>
          </a:p>
        </p:txBody>
      </p:sp>
      <p:sp>
        <p:nvSpPr>
          <p:cNvPr id="7" name="Slide Number Placeholder 6"/>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35272309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97E1E91-DF44-E34B-9400-88125B7FBE4D}" type="datetimeFigureOut">
              <a:rPr lang="en-SA" smtClean="0"/>
              <a:t>15/11/2025 R</a:t>
            </a:fld>
            <a:endParaRPr lang="en-SA"/>
          </a:p>
        </p:txBody>
      </p:sp>
      <p:sp>
        <p:nvSpPr>
          <p:cNvPr id="6" name="Footer Placeholder 5"/>
          <p:cNvSpPr>
            <a:spLocks noGrp="1"/>
          </p:cNvSpPr>
          <p:nvPr>
            <p:ph type="ftr" sz="quarter" idx="11"/>
          </p:nvPr>
        </p:nvSpPr>
        <p:spPr/>
        <p:txBody>
          <a:bodyPr/>
          <a:lstStyle/>
          <a:p>
            <a:endParaRPr lang="en-SA"/>
          </a:p>
        </p:txBody>
      </p:sp>
      <p:sp>
        <p:nvSpPr>
          <p:cNvPr id="7" name="Slide Number Placeholder 6"/>
          <p:cNvSpPr>
            <a:spLocks noGrp="1"/>
          </p:cNvSpPr>
          <p:nvPr>
            <p:ph type="sldNum" sz="quarter" idx="12"/>
          </p:nvPr>
        </p:nvSpPr>
        <p:spPr/>
        <p:txBody>
          <a:bodyPr/>
          <a:lstStyle/>
          <a:p>
            <a:fld id="{CA34A919-91BC-6044-BB6A-16864B8F6ED1}" type="slidenum">
              <a:rPr lang="en-SA" smtClean="0"/>
              <a:t>‹#›</a:t>
            </a:fld>
            <a:endParaRPr lang="en-SA"/>
          </a:p>
        </p:txBody>
      </p:sp>
    </p:spTree>
    <p:extLst>
      <p:ext uri="{BB962C8B-B14F-4D97-AF65-F5344CB8AC3E}">
        <p14:creationId xmlns:p14="http://schemas.microsoft.com/office/powerpoint/2010/main" val="22999239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E97E1E91-DF44-E34B-9400-88125B7FBE4D}" type="datetimeFigureOut">
              <a:rPr lang="en-SA" smtClean="0"/>
              <a:t>15/11/2025 R</a:t>
            </a:fld>
            <a:endParaRPr lang="en-S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S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CA34A919-91BC-6044-BB6A-16864B8F6ED1}" type="slidenum">
              <a:rPr lang="en-SA" smtClean="0"/>
              <a:t>‹#›</a:t>
            </a:fld>
            <a:endParaRPr lang="en-SA"/>
          </a:p>
        </p:txBody>
      </p:sp>
    </p:spTree>
    <p:extLst>
      <p:ext uri="{BB962C8B-B14F-4D97-AF65-F5344CB8AC3E}">
        <p14:creationId xmlns:p14="http://schemas.microsoft.com/office/powerpoint/2010/main" val="9552346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5.svg"/><Relationship Id="rId5" Type="http://schemas.openxmlformats.org/officeDocument/2006/relationships/image" Target="../media/image4.png"/><Relationship Id="rId4" Type="http://schemas.openxmlformats.org/officeDocument/2006/relationships/image" Target="../media/image3.sv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9.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DE7D5410-C6B7-17EF-04BB-718DBCAA88E0}"/>
              </a:ext>
            </a:extLst>
          </p:cNvPr>
          <p:cNvSpPr txBox="1">
            <a:spLocks/>
          </p:cNvSpPr>
          <p:nvPr/>
        </p:nvSpPr>
        <p:spPr>
          <a:xfrm>
            <a:off x="20544" y="17093"/>
            <a:ext cx="6555659"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US" sz="2400" b="1" dirty="0">
                <a:latin typeface="Arial" panose="020B0604020202020204" pitchFamily="34" charset="0"/>
                <a:cs typeface="Arial" panose="020B0604020202020204" pitchFamily="34" charset="0"/>
              </a:rPr>
              <a:t>Supplementary Figure </a:t>
            </a:r>
            <a:r>
              <a:rPr lang="en-SA" sz="2400" b="1" dirty="0">
                <a:latin typeface="Arial" panose="020B0604020202020204" pitchFamily="34" charset="0"/>
                <a:cs typeface="Arial" panose="020B0604020202020204" pitchFamily="34" charset="0"/>
              </a:rPr>
              <a:t>1</a:t>
            </a:r>
          </a:p>
        </p:txBody>
      </p:sp>
      <p:pic>
        <p:nvPicPr>
          <p:cNvPr id="15" name="Picture 14">
            <a:extLst>
              <a:ext uri="{FF2B5EF4-FFF2-40B4-BE49-F238E27FC236}">
                <a16:creationId xmlns:a16="http://schemas.microsoft.com/office/drawing/2014/main" id="{FA2FFAC0-52FE-7F4A-FC42-83655448921A}"/>
              </a:ext>
            </a:extLst>
          </p:cNvPr>
          <p:cNvPicPr>
            <a:picLocks noChangeAspect="1"/>
          </p:cNvPicPr>
          <p:nvPr/>
        </p:nvPicPr>
        <p:blipFill>
          <a:blip r:embed="rId3"/>
          <a:stretch>
            <a:fillRect/>
          </a:stretch>
        </p:blipFill>
        <p:spPr>
          <a:xfrm>
            <a:off x="555173" y="902226"/>
            <a:ext cx="5881556" cy="3471752"/>
          </a:xfrm>
          <a:prstGeom prst="rect">
            <a:avLst/>
          </a:prstGeom>
        </p:spPr>
      </p:pic>
      <p:sp>
        <p:nvSpPr>
          <p:cNvPr id="3" name="TextBox 2">
            <a:extLst>
              <a:ext uri="{FF2B5EF4-FFF2-40B4-BE49-F238E27FC236}">
                <a16:creationId xmlns:a16="http://schemas.microsoft.com/office/drawing/2014/main" id="{A072EEA4-2C68-EFC7-71AE-56DD49B78AEC}"/>
              </a:ext>
            </a:extLst>
          </p:cNvPr>
          <p:cNvSpPr txBox="1"/>
          <p:nvPr/>
        </p:nvSpPr>
        <p:spPr>
          <a:xfrm>
            <a:off x="473758" y="4984222"/>
            <a:ext cx="5962971" cy="1077218"/>
          </a:xfrm>
          <a:prstGeom prst="rect">
            <a:avLst/>
          </a:prstGeom>
          <a:noFill/>
        </p:spPr>
        <p:txBody>
          <a:bodyPr wrap="square">
            <a:spAutoFit/>
          </a:bodyPr>
          <a:lstStyle/>
          <a:p>
            <a:r>
              <a:rPr lang="en-US" sz="1600" b="1" dirty="0">
                <a:latin typeface="Arial" panose="020B0604020202020204" pitchFamily="34" charset="0"/>
                <a:cs typeface="Arial" panose="020B0604020202020204" pitchFamily="34" charset="0"/>
              </a:rPr>
              <a:t>Supplementary Figure 1. </a:t>
            </a:r>
            <a:r>
              <a:rPr lang="en-US" sz="1600" dirty="0">
                <a:latin typeface="Arial" panose="020B0604020202020204" pitchFamily="34" charset="0"/>
                <a:cs typeface="Arial" panose="020B0604020202020204" pitchFamily="34" charset="0"/>
              </a:rPr>
              <a:t>The distribution of mutations across WDR33 CPA gene domains. Somatic mutation rate relative to all TCGA samples for WDR33. Y-axes indicate number of mutations for each specific variant.</a:t>
            </a:r>
          </a:p>
        </p:txBody>
      </p:sp>
    </p:spTree>
    <p:extLst>
      <p:ext uri="{BB962C8B-B14F-4D97-AF65-F5344CB8AC3E}">
        <p14:creationId xmlns:p14="http://schemas.microsoft.com/office/powerpoint/2010/main" val="5158397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Graphic 18">
            <a:extLst>
              <a:ext uri="{FF2B5EF4-FFF2-40B4-BE49-F238E27FC236}">
                <a16:creationId xmlns:a16="http://schemas.microsoft.com/office/drawing/2014/main" id="{4D4330D7-30BD-1719-B711-593DC0AC77D5}"/>
              </a:ext>
            </a:extLst>
          </p:cNvPr>
          <p:cNvPicPr>
            <a:picLocks noChangeAspect="1"/>
          </p:cNvPicPr>
          <p:nvPr/>
        </p:nvPicPr>
        <p:blipFill rotWithShape="1">
          <a:blip r:embed="rId3">
            <a:extLst>
              <a:ext uri="{96DAC541-7B7A-43D3-8B79-37D633B846F1}">
                <asvg:svgBlip xmlns:asvg="http://schemas.microsoft.com/office/drawing/2016/SVG/main" r:embed="rId4"/>
              </a:ext>
            </a:extLst>
          </a:blip>
          <a:srcRect b="25273"/>
          <a:stretch/>
        </p:blipFill>
        <p:spPr>
          <a:xfrm>
            <a:off x="1271856" y="4347972"/>
            <a:ext cx="4053034" cy="3028714"/>
          </a:xfrm>
          <a:prstGeom prst="rect">
            <a:avLst/>
          </a:prstGeom>
        </p:spPr>
      </p:pic>
      <p:sp>
        <p:nvSpPr>
          <p:cNvPr id="8" name="Title 1">
            <a:extLst>
              <a:ext uri="{FF2B5EF4-FFF2-40B4-BE49-F238E27FC236}">
                <a16:creationId xmlns:a16="http://schemas.microsoft.com/office/drawing/2014/main" id="{DE7D5410-C6B7-17EF-04BB-718DBCAA88E0}"/>
              </a:ext>
            </a:extLst>
          </p:cNvPr>
          <p:cNvSpPr txBox="1">
            <a:spLocks/>
          </p:cNvSpPr>
          <p:nvPr/>
        </p:nvSpPr>
        <p:spPr>
          <a:xfrm>
            <a:off x="20544" y="17093"/>
            <a:ext cx="6555659"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US" sz="2400" b="1" dirty="0">
                <a:latin typeface="Arial" panose="020B0604020202020204" pitchFamily="34" charset="0"/>
                <a:cs typeface="Arial" panose="020B0604020202020204" pitchFamily="34" charset="0"/>
              </a:rPr>
              <a:t>Supplementary Figure 2</a:t>
            </a:r>
            <a:endParaRPr lang="en-SA" sz="2400" b="1" dirty="0">
              <a:latin typeface="Arial" panose="020B0604020202020204" pitchFamily="34" charset="0"/>
              <a:cs typeface="Arial" panose="020B0604020202020204" pitchFamily="34" charset="0"/>
            </a:endParaRPr>
          </a:p>
        </p:txBody>
      </p:sp>
      <p:sp>
        <p:nvSpPr>
          <p:cNvPr id="9" name="Title 1">
            <a:extLst>
              <a:ext uri="{FF2B5EF4-FFF2-40B4-BE49-F238E27FC236}">
                <a16:creationId xmlns:a16="http://schemas.microsoft.com/office/drawing/2014/main" id="{4191F70E-4040-75CB-6D5C-D414A5F7C985}"/>
              </a:ext>
            </a:extLst>
          </p:cNvPr>
          <p:cNvSpPr txBox="1">
            <a:spLocks/>
          </p:cNvSpPr>
          <p:nvPr/>
        </p:nvSpPr>
        <p:spPr>
          <a:xfrm>
            <a:off x="158923" y="566188"/>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SA" sz="2000" b="1" dirty="0">
                <a:latin typeface="Arial" panose="020B0604020202020204" pitchFamily="34" charset="0"/>
                <a:cs typeface="Arial" panose="020B0604020202020204" pitchFamily="34" charset="0"/>
              </a:rPr>
              <a:t>A</a:t>
            </a:r>
          </a:p>
        </p:txBody>
      </p:sp>
      <p:pic>
        <p:nvPicPr>
          <p:cNvPr id="11" name="Graphic 10">
            <a:extLst>
              <a:ext uri="{FF2B5EF4-FFF2-40B4-BE49-F238E27FC236}">
                <a16:creationId xmlns:a16="http://schemas.microsoft.com/office/drawing/2014/main" id="{D05A295C-70A2-6E46-1B19-AA2401E5AE14}"/>
              </a:ext>
            </a:extLst>
          </p:cNvPr>
          <p:cNvPicPr>
            <a:picLocks noChangeAspect="1"/>
          </p:cNvPicPr>
          <p:nvPr/>
        </p:nvPicPr>
        <p:blipFill rotWithShape="1">
          <a:blip r:embed="rId5">
            <a:extLst>
              <a:ext uri="{96DAC541-7B7A-43D3-8B79-37D633B846F1}">
                <asvg:svgBlip xmlns:asvg="http://schemas.microsoft.com/office/drawing/2016/SVG/main" r:embed="rId6"/>
              </a:ext>
            </a:extLst>
          </a:blip>
          <a:srcRect b="25273"/>
          <a:stretch/>
        </p:blipFill>
        <p:spPr>
          <a:xfrm>
            <a:off x="1271856" y="840479"/>
            <a:ext cx="4053034" cy="3028714"/>
          </a:xfrm>
          <a:prstGeom prst="rect">
            <a:avLst/>
          </a:prstGeom>
        </p:spPr>
      </p:pic>
      <p:sp>
        <p:nvSpPr>
          <p:cNvPr id="27" name="Title 1">
            <a:extLst>
              <a:ext uri="{FF2B5EF4-FFF2-40B4-BE49-F238E27FC236}">
                <a16:creationId xmlns:a16="http://schemas.microsoft.com/office/drawing/2014/main" id="{05F7EE7D-EB7B-64BD-056D-D4F21E95B482}"/>
              </a:ext>
            </a:extLst>
          </p:cNvPr>
          <p:cNvSpPr txBox="1">
            <a:spLocks/>
          </p:cNvSpPr>
          <p:nvPr/>
        </p:nvSpPr>
        <p:spPr>
          <a:xfrm>
            <a:off x="158922" y="3758037"/>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SA" sz="2000"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7892022D-E36A-1AFA-4834-85E1DF12BAC9}"/>
              </a:ext>
            </a:extLst>
          </p:cNvPr>
          <p:cNvSpPr txBox="1"/>
          <p:nvPr/>
        </p:nvSpPr>
        <p:spPr>
          <a:xfrm>
            <a:off x="377580" y="7472687"/>
            <a:ext cx="6102840" cy="1569660"/>
          </a:xfrm>
          <a:prstGeom prst="rect">
            <a:avLst/>
          </a:prstGeom>
          <a:noFill/>
        </p:spPr>
        <p:txBody>
          <a:bodyPr wrap="square">
            <a:spAutoFit/>
          </a:bodyPr>
          <a:lstStyle/>
          <a:p>
            <a:r>
              <a:rPr lang="en-US" sz="1600" b="1" dirty="0">
                <a:latin typeface="Arial" panose="020B0604020202020204" pitchFamily="34" charset="0"/>
                <a:cs typeface="Arial" panose="020B0604020202020204" pitchFamily="34" charset="0"/>
              </a:rPr>
              <a:t>Supplementary Figure 2. </a:t>
            </a:r>
            <a:r>
              <a:rPr lang="en-US" sz="1600" dirty="0">
                <a:latin typeface="Arial" panose="020B0604020202020204" pitchFamily="34" charset="0"/>
                <a:cs typeface="Arial" panose="020B0604020202020204" pitchFamily="34" charset="0"/>
              </a:rPr>
              <a:t>The association between mutation status and patient outcomes in the WDR33 CPA gene. </a:t>
            </a:r>
            <a:r>
              <a:rPr lang="en-SA" sz="1600" dirty="0">
                <a:latin typeface="Arial" panose="020B0604020202020204" pitchFamily="34" charset="0"/>
                <a:cs typeface="Arial" panose="020B0604020202020204" pitchFamily="34" charset="0"/>
              </a:rPr>
              <a:t>Kaplan-Meier curves showing </a:t>
            </a:r>
            <a:r>
              <a:rPr lang="en-US" sz="1600" dirty="0">
                <a:latin typeface="Arial" panose="020B0604020202020204" pitchFamily="34" charset="0"/>
                <a:cs typeface="Arial" panose="020B0604020202020204" pitchFamily="34" charset="0"/>
              </a:rPr>
              <a:t>overall and progression-free survival for PCF11 (A and B) and WDR33 (C and D). “Blue” indicates patients with no mutation (wild type; “</a:t>
            </a:r>
            <a:r>
              <a:rPr lang="en-US" sz="1600" dirty="0" err="1">
                <a:latin typeface="Arial" panose="020B0604020202020204" pitchFamily="34" charset="0"/>
                <a:cs typeface="Arial" panose="020B0604020202020204" pitchFamily="34" charset="0"/>
              </a:rPr>
              <a:t>wt</a:t>
            </a:r>
            <a:r>
              <a:rPr lang="en-US" sz="1600" dirty="0">
                <a:latin typeface="Arial" panose="020B0604020202020204" pitchFamily="34" charset="0"/>
                <a:cs typeface="Arial" panose="020B0604020202020204" pitchFamily="34" charset="0"/>
              </a:rPr>
              <a:t>”) while “Red” indicates patients with mutations; ”mut”. </a:t>
            </a:r>
            <a:endParaRPr lang="en-SA"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54185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DE7D5410-C6B7-17EF-04BB-718DBCAA88E0}"/>
              </a:ext>
            </a:extLst>
          </p:cNvPr>
          <p:cNvSpPr txBox="1">
            <a:spLocks/>
          </p:cNvSpPr>
          <p:nvPr/>
        </p:nvSpPr>
        <p:spPr>
          <a:xfrm>
            <a:off x="20544" y="17093"/>
            <a:ext cx="6555659"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US" sz="2400" b="1" dirty="0">
                <a:latin typeface="Arial" panose="020B0604020202020204" pitchFamily="34" charset="0"/>
                <a:cs typeface="Arial" panose="020B0604020202020204" pitchFamily="34" charset="0"/>
              </a:rPr>
              <a:t>Supplementary Figure 3</a:t>
            </a:r>
            <a:endParaRPr lang="en-SA" sz="2400" b="1" dirty="0">
              <a:latin typeface="Arial" panose="020B0604020202020204" pitchFamily="34" charset="0"/>
              <a:cs typeface="Arial" panose="020B0604020202020204" pitchFamily="34" charset="0"/>
            </a:endParaRPr>
          </a:p>
        </p:txBody>
      </p:sp>
      <p:grpSp>
        <p:nvGrpSpPr>
          <p:cNvPr id="11" name="Group 10">
            <a:extLst>
              <a:ext uri="{FF2B5EF4-FFF2-40B4-BE49-F238E27FC236}">
                <a16:creationId xmlns:a16="http://schemas.microsoft.com/office/drawing/2014/main" id="{FEA265D2-D9CA-AE23-1441-349E4148DA4E}"/>
              </a:ext>
            </a:extLst>
          </p:cNvPr>
          <p:cNvGrpSpPr/>
          <p:nvPr/>
        </p:nvGrpSpPr>
        <p:grpSpPr>
          <a:xfrm>
            <a:off x="308082" y="473522"/>
            <a:ext cx="6470438" cy="3346512"/>
            <a:chOff x="308082" y="819257"/>
            <a:chExt cx="6470438" cy="3346512"/>
          </a:xfrm>
        </p:grpSpPr>
        <p:pic>
          <p:nvPicPr>
            <p:cNvPr id="10" name="Picture 9">
              <a:extLst>
                <a:ext uri="{FF2B5EF4-FFF2-40B4-BE49-F238E27FC236}">
                  <a16:creationId xmlns:a16="http://schemas.microsoft.com/office/drawing/2014/main" id="{AFEF22F9-1029-49D6-751A-F3E1A4DEB9E5}"/>
                </a:ext>
              </a:extLst>
            </p:cNvPr>
            <p:cNvPicPr>
              <a:picLocks noChangeAspect="1"/>
            </p:cNvPicPr>
            <p:nvPr/>
          </p:nvPicPr>
          <p:blipFill>
            <a:blip r:embed="rId3"/>
            <a:srcRect t="8095"/>
            <a:stretch/>
          </p:blipFill>
          <p:spPr>
            <a:xfrm>
              <a:off x="308082" y="895079"/>
              <a:ext cx="6470438" cy="3270690"/>
            </a:xfrm>
            <a:prstGeom prst="rect">
              <a:avLst/>
            </a:prstGeom>
          </p:spPr>
        </p:pic>
        <p:sp>
          <p:nvSpPr>
            <p:cNvPr id="4" name="Rectangle 3">
              <a:extLst>
                <a:ext uri="{FF2B5EF4-FFF2-40B4-BE49-F238E27FC236}">
                  <a16:creationId xmlns:a16="http://schemas.microsoft.com/office/drawing/2014/main" id="{8D7956A7-97E2-57C5-0CA4-609E0DF1AC93}"/>
                </a:ext>
              </a:extLst>
            </p:cNvPr>
            <p:cNvSpPr/>
            <p:nvPr/>
          </p:nvSpPr>
          <p:spPr>
            <a:xfrm>
              <a:off x="559361" y="819257"/>
              <a:ext cx="4130626" cy="68825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0" marR="0" lvl="0" indent="0" algn="ctr" defTabSz="457200" rtl="0" eaLnBrk="1" fontAlgn="auto" latinLnBrk="0" hangingPunct="1">
                <a:lnSpc>
                  <a:spcPct val="100000"/>
                </a:lnSpc>
                <a:spcBef>
                  <a:spcPts val="0"/>
                </a:spcBef>
                <a:spcAft>
                  <a:spcPts val="0"/>
                </a:spcAft>
                <a:buClrTx/>
                <a:buSzTx/>
                <a:buFontTx/>
                <a:buNone/>
                <a:tabLst/>
                <a:defRPr/>
              </a:pPr>
              <a:endParaRPr lang="en-US" sz="1200" dirty="0">
                <a:solidFill>
                  <a:prstClr val="black"/>
                </a:solidFill>
                <a:latin typeface="Arial" panose="020B0604020202020204" pitchFamily="34" charset="0"/>
                <a:cs typeface="Arial" panose="020B0604020202020204" pitchFamily="34" charset="0"/>
              </a:endParaRP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ll CNV alterations</a:t>
              </a:r>
            </a:p>
          </p:txBody>
        </p:sp>
      </p:grpSp>
      <p:grpSp>
        <p:nvGrpSpPr>
          <p:cNvPr id="5" name="Group 4">
            <a:extLst>
              <a:ext uri="{FF2B5EF4-FFF2-40B4-BE49-F238E27FC236}">
                <a16:creationId xmlns:a16="http://schemas.microsoft.com/office/drawing/2014/main" id="{FE249E27-A5AC-FFDB-88BE-A25CD3CD13E2}"/>
              </a:ext>
            </a:extLst>
          </p:cNvPr>
          <p:cNvGrpSpPr/>
          <p:nvPr/>
        </p:nvGrpSpPr>
        <p:grpSpPr>
          <a:xfrm>
            <a:off x="308082" y="3776956"/>
            <a:ext cx="6470436" cy="3345559"/>
            <a:chOff x="505096" y="4159052"/>
            <a:chExt cx="6470436" cy="3345559"/>
          </a:xfrm>
        </p:grpSpPr>
        <p:pic>
          <p:nvPicPr>
            <p:cNvPr id="6" name="Picture 5">
              <a:extLst>
                <a:ext uri="{FF2B5EF4-FFF2-40B4-BE49-F238E27FC236}">
                  <a16:creationId xmlns:a16="http://schemas.microsoft.com/office/drawing/2014/main" id="{E67B6A8B-136C-82F1-A2CE-74C12809687E}"/>
                </a:ext>
              </a:extLst>
            </p:cNvPr>
            <p:cNvPicPr>
              <a:picLocks noChangeAspect="1"/>
            </p:cNvPicPr>
            <p:nvPr/>
          </p:nvPicPr>
          <p:blipFill>
            <a:blip r:embed="rId4"/>
            <a:srcRect t="8357"/>
            <a:stretch/>
          </p:blipFill>
          <p:spPr>
            <a:xfrm>
              <a:off x="505096" y="4243283"/>
              <a:ext cx="6470436" cy="3261328"/>
            </a:xfrm>
            <a:prstGeom prst="rect">
              <a:avLst/>
            </a:prstGeom>
          </p:spPr>
        </p:pic>
        <p:sp>
          <p:nvSpPr>
            <p:cNvPr id="7" name="Rectangle 6">
              <a:extLst>
                <a:ext uri="{FF2B5EF4-FFF2-40B4-BE49-F238E27FC236}">
                  <a16:creationId xmlns:a16="http://schemas.microsoft.com/office/drawing/2014/main" id="{F7C05FEB-B130-7BF4-F484-E7115FD91B3D}"/>
                </a:ext>
              </a:extLst>
            </p:cNvPr>
            <p:cNvSpPr/>
            <p:nvPr/>
          </p:nvSpPr>
          <p:spPr>
            <a:xfrm>
              <a:off x="697013" y="4159052"/>
              <a:ext cx="4189988" cy="68825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NV </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Gain and Shallow deletion)</a:t>
              </a:r>
            </a:p>
          </p:txBody>
        </p:sp>
      </p:grpSp>
      <p:sp>
        <p:nvSpPr>
          <p:cNvPr id="9" name="Title 1">
            <a:extLst>
              <a:ext uri="{FF2B5EF4-FFF2-40B4-BE49-F238E27FC236}">
                <a16:creationId xmlns:a16="http://schemas.microsoft.com/office/drawing/2014/main" id="{4191F70E-4040-75CB-6D5C-D414A5F7C985}"/>
              </a:ext>
            </a:extLst>
          </p:cNvPr>
          <p:cNvSpPr txBox="1">
            <a:spLocks/>
          </p:cNvSpPr>
          <p:nvPr/>
        </p:nvSpPr>
        <p:spPr>
          <a:xfrm>
            <a:off x="-18284" y="644218"/>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SA" sz="2000" b="1" dirty="0">
                <a:latin typeface="Arial" panose="020B0604020202020204" pitchFamily="34" charset="0"/>
                <a:cs typeface="Arial" panose="020B0604020202020204" pitchFamily="34" charset="0"/>
              </a:rPr>
              <a:t>A</a:t>
            </a:r>
          </a:p>
        </p:txBody>
      </p:sp>
      <p:sp>
        <p:nvSpPr>
          <p:cNvPr id="3" name="Title 1">
            <a:extLst>
              <a:ext uri="{FF2B5EF4-FFF2-40B4-BE49-F238E27FC236}">
                <a16:creationId xmlns:a16="http://schemas.microsoft.com/office/drawing/2014/main" id="{4AF8FD2D-29A2-872F-67BD-A691BAF116AF}"/>
              </a:ext>
            </a:extLst>
          </p:cNvPr>
          <p:cNvSpPr txBox="1">
            <a:spLocks/>
          </p:cNvSpPr>
          <p:nvPr/>
        </p:nvSpPr>
        <p:spPr>
          <a:xfrm>
            <a:off x="-18284" y="3817977"/>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US" sz="2000" b="1" dirty="0">
                <a:latin typeface="Arial" panose="020B0604020202020204" pitchFamily="34" charset="0"/>
                <a:cs typeface="Arial" panose="020B0604020202020204" pitchFamily="34" charset="0"/>
              </a:rPr>
              <a:t>B</a:t>
            </a:r>
            <a:endParaRPr lang="en-SA" sz="20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10EB0E06-2508-8D53-15BD-138270852712}"/>
              </a:ext>
            </a:extLst>
          </p:cNvPr>
          <p:cNvSpPr txBox="1"/>
          <p:nvPr/>
        </p:nvSpPr>
        <p:spPr>
          <a:xfrm>
            <a:off x="124671" y="7227463"/>
            <a:ext cx="6712064" cy="209288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b="1" dirty="0">
                <a:latin typeface="Arial" panose="020B0604020202020204" pitchFamily="34" charset="0"/>
                <a:cs typeface="Arial" panose="020B0604020202020204" pitchFamily="34" charset="0"/>
              </a:rPr>
              <a:t>Supplementary Figure </a:t>
            </a:r>
            <a:r>
              <a:rPr lang="en-SA" sz="1600" b="1" dirty="0">
                <a:latin typeface="Arial" panose="020B0604020202020204" pitchFamily="34" charset="0"/>
                <a:cs typeface="Arial" panose="020B0604020202020204" pitchFamily="34" charset="0"/>
              </a:rPr>
              <a:t>3. </a:t>
            </a:r>
            <a:r>
              <a:rPr lang="en-US" sz="1600" dirty="0">
                <a:latin typeface="Arial" panose="020B0604020202020204" pitchFamily="34" charset="0"/>
                <a:cs typeface="Arial" panose="020B0604020202020204" pitchFamily="34" charset="0"/>
              </a:rPr>
              <a:t>Pan-cancer landscape of copy number alterations in CPA genes. </a:t>
            </a:r>
            <a:r>
              <a:rPr lang="en-SA" sz="1600" dirty="0">
                <a:latin typeface="Arial" panose="020B0604020202020204" pitchFamily="34" charset="0"/>
                <a:cs typeface="Arial" panose="020B0604020202020204" pitchFamily="34" charset="0"/>
              </a:rPr>
              <a:t>The oncoplot shows the percentages of copy number variations (CNV) in 16 CPA genes across 33 cancer types from TCGA. A, All copy number alterations including amplification (red), gain (light red), shallow deletion (light blue) and deep deletion (blue). B, Only gain (light red) and shallow deletion (light blue) CNV are shown. Diploid (grey) denotes normal copy number.</a:t>
            </a:r>
          </a:p>
          <a:p>
            <a:endParaRPr lang="en-SA"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650401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DE7D5410-C6B7-17EF-04BB-718DBCAA88E0}"/>
              </a:ext>
            </a:extLst>
          </p:cNvPr>
          <p:cNvSpPr txBox="1">
            <a:spLocks/>
          </p:cNvSpPr>
          <p:nvPr/>
        </p:nvSpPr>
        <p:spPr>
          <a:xfrm>
            <a:off x="20544" y="17093"/>
            <a:ext cx="6555659"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US" sz="2400" b="1" dirty="0">
                <a:latin typeface="Arial" panose="020B0604020202020204" pitchFamily="34" charset="0"/>
                <a:cs typeface="Arial" panose="020B0604020202020204" pitchFamily="34" charset="0"/>
              </a:rPr>
              <a:t>Supplementary Figure 4</a:t>
            </a:r>
            <a:endParaRPr lang="en-SA" sz="2400" b="1" dirty="0">
              <a:latin typeface="Arial" panose="020B0604020202020204" pitchFamily="34" charset="0"/>
              <a:cs typeface="Arial" panose="020B0604020202020204" pitchFamily="34" charset="0"/>
            </a:endParaRPr>
          </a:p>
        </p:txBody>
      </p:sp>
      <p:sp>
        <p:nvSpPr>
          <p:cNvPr id="9" name="Title 1">
            <a:extLst>
              <a:ext uri="{FF2B5EF4-FFF2-40B4-BE49-F238E27FC236}">
                <a16:creationId xmlns:a16="http://schemas.microsoft.com/office/drawing/2014/main" id="{4191F70E-4040-75CB-6D5C-D414A5F7C985}"/>
              </a:ext>
            </a:extLst>
          </p:cNvPr>
          <p:cNvSpPr txBox="1">
            <a:spLocks/>
          </p:cNvSpPr>
          <p:nvPr/>
        </p:nvSpPr>
        <p:spPr>
          <a:xfrm>
            <a:off x="39655" y="566188"/>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SA" sz="2000" b="1" dirty="0">
                <a:latin typeface="Arial" panose="020B0604020202020204" pitchFamily="34" charset="0"/>
                <a:cs typeface="Arial" panose="020B0604020202020204" pitchFamily="34" charset="0"/>
              </a:rPr>
              <a:t>A</a:t>
            </a:r>
          </a:p>
        </p:txBody>
      </p:sp>
      <p:sp>
        <p:nvSpPr>
          <p:cNvPr id="27" name="Title 1">
            <a:extLst>
              <a:ext uri="{FF2B5EF4-FFF2-40B4-BE49-F238E27FC236}">
                <a16:creationId xmlns:a16="http://schemas.microsoft.com/office/drawing/2014/main" id="{05F7EE7D-EB7B-64BD-056D-D4F21E95B482}"/>
              </a:ext>
            </a:extLst>
          </p:cNvPr>
          <p:cNvSpPr txBox="1">
            <a:spLocks/>
          </p:cNvSpPr>
          <p:nvPr/>
        </p:nvSpPr>
        <p:spPr>
          <a:xfrm>
            <a:off x="3309732" y="561339"/>
            <a:ext cx="715297" cy="589935"/>
          </a:xfrm>
          <a:prstGeom prst="rect">
            <a:avLst/>
          </a:prstGeom>
        </p:spPr>
        <p:txBody>
          <a:bodyPr vert="horz" lIns="91440" tIns="45720" rIns="91440" bIns="45720" rtlCol="0" anchor="ctr">
            <a:norm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r>
              <a:rPr lang="en-SA" sz="2000"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7892022D-E36A-1AFA-4834-85E1DF12BAC9}"/>
              </a:ext>
            </a:extLst>
          </p:cNvPr>
          <p:cNvSpPr txBox="1"/>
          <p:nvPr/>
        </p:nvSpPr>
        <p:spPr>
          <a:xfrm>
            <a:off x="351080" y="4348490"/>
            <a:ext cx="6135672" cy="830997"/>
          </a:xfrm>
          <a:prstGeom prst="rect">
            <a:avLst/>
          </a:prstGeom>
          <a:noFill/>
        </p:spPr>
        <p:txBody>
          <a:bodyPr wrap="square">
            <a:spAutoFit/>
          </a:bodyPr>
          <a:lstStyle/>
          <a:p>
            <a:r>
              <a:rPr lang="en-US" sz="1600" b="1" dirty="0">
                <a:latin typeface="Arial" panose="020B0604020202020204" pitchFamily="34" charset="0"/>
                <a:cs typeface="Arial" panose="020B0604020202020204" pitchFamily="34" charset="0"/>
              </a:rPr>
              <a:t>Supplementary Figure 4. </a:t>
            </a:r>
            <a:r>
              <a:rPr lang="en-US" sz="1600" dirty="0">
                <a:latin typeface="Arial" panose="020B0604020202020204" pitchFamily="34" charset="0"/>
                <a:cs typeface="Arial" panose="020B0604020202020204" pitchFamily="34" charset="0"/>
              </a:rPr>
              <a:t>Representative APA altered genes. A, Representative 3'UTR lengthening genes. B, Representative 3'UTR shortening genes.</a:t>
            </a:r>
            <a:endParaRPr lang="en-SA" sz="1600"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1C0F22D7-2ADC-4CCB-BEF5-EFF8E0C0A923}"/>
              </a:ext>
            </a:extLst>
          </p:cNvPr>
          <p:cNvPicPr>
            <a:picLocks noChangeAspect="1"/>
          </p:cNvPicPr>
          <p:nvPr/>
        </p:nvPicPr>
        <p:blipFill>
          <a:blip r:embed="rId3"/>
          <a:stretch>
            <a:fillRect/>
          </a:stretch>
        </p:blipFill>
        <p:spPr>
          <a:xfrm>
            <a:off x="351080" y="1036021"/>
            <a:ext cx="2828025" cy="2883476"/>
          </a:xfrm>
          <a:prstGeom prst="rect">
            <a:avLst/>
          </a:prstGeom>
        </p:spPr>
      </p:pic>
      <p:pic>
        <p:nvPicPr>
          <p:cNvPr id="6" name="Picture 5">
            <a:extLst>
              <a:ext uri="{FF2B5EF4-FFF2-40B4-BE49-F238E27FC236}">
                <a16:creationId xmlns:a16="http://schemas.microsoft.com/office/drawing/2014/main" id="{37D6F936-1D93-8DAF-FCA9-82BD6A83482D}"/>
              </a:ext>
            </a:extLst>
          </p:cNvPr>
          <p:cNvPicPr>
            <a:picLocks noChangeAspect="1"/>
          </p:cNvPicPr>
          <p:nvPr/>
        </p:nvPicPr>
        <p:blipFill>
          <a:blip r:embed="rId4"/>
          <a:stretch>
            <a:fillRect/>
          </a:stretch>
        </p:blipFill>
        <p:spPr>
          <a:xfrm>
            <a:off x="3658727" y="1036021"/>
            <a:ext cx="2828025" cy="2883476"/>
          </a:xfrm>
          <a:prstGeom prst="rect">
            <a:avLst/>
          </a:prstGeom>
        </p:spPr>
      </p:pic>
    </p:spTree>
    <p:extLst>
      <p:ext uri="{BB962C8B-B14F-4D97-AF65-F5344CB8AC3E}">
        <p14:creationId xmlns:p14="http://schemas.microsoft.com/office/powerpoint/2010/main" val="31074366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3</TotalTime>
  <Words>249</Words>
  <Application>Microsoft Macintosh PowerPoint</Application>
  <PresentationFormat>Letter Paper (8.5x11 in)</PresentationFormat>
  <Paragraphs>24</Paragraphs>
  <Slides>4</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ptos</vt:lpstr>
      <vt:lpstr>Aptos Display</vt:lpstr>
      <vt:lpstr>Arial</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 Alahmari</dc:creator>
  <cp:lastModifiedBy>A. Alahmari</cp:lastModifiedBy>
  <cp:revision>1</cp:revision>
  <dcterms:created xsi:type="dcterms:W3CDTF">2025-07-11T18:17:20Z</dcterms:created>
  <dcterms:modified xsi:type="dcterms:W3CDTF">2025-11-15T07:13:24Z</dcterms:modified>
</cp:coreProperties>
</file>